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EAC903-AC28-4B3B-9D6A-688B378922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23357D-120A-460A-B553-F72DB17439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30B73A-6F75-49B8-84A8-EE2BA019D9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6B4EA-B12B-4CC8-965F-AFD6FEB3C1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54AA7C-BBB9-4C47-A010-6AD4142C71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DB4C4-F07E-4183-A44B-D9F81A9602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37D210-6C99-4A1F-9034-21846C2501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6755D-CBEC-4EFF-A2CA-B76AB4E8CB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164AF1-0EED-4D6C-9B64-63BD259E55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202331-B495-4F7F-BEA1-432A71EB1E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3D630-A3C8-49CD-85CE-B7CD3CAFCA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34A79C-40CA-485D-A772-71B9FF224B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F9E0D0-B740-45F0-98F5-C2BA48641B9A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7280" y="5943600"/>
            <a:ext cx="6264360" cy="10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data file 5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1300" spc="-1" strike="noStrike">
                <a:solidFill>
                  <a:srgbClr val="000000"/>
                </a:solidFill>
                <a:latin typeface="Arial"/>
              </a:rPr>
              <a:t>-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road-range metal uptake system mutants affecting Cd toleranc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erial dilution assays (see ‘Materials and methods’ for details) comparing Cd tolerance of WT cells and of mutant strains deleted in the broad-range transporters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FET4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SMF1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, and in the negative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FET4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regulator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OX1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305000" y="2252520"/>
            <a:ext cx="4656240" cy="3073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3T05:44:42Z</dcterms:created>
  <dc:creator>Roberta</dc:creator>
  <dc:description/>
  <dc:language>en-US</dc:language>
  <cp:lastModifiedBy>Dipartimento di Biochimica e Biologia Molecolare</cp:lastModifiedBy>
  <dcterms:modified xsi:type="dcterms:W3CDTF">2008-04-04T15:08:05Z</dcterms:modified>
  <cp:revision>12</cp:revision>
  <dc:subject/>
  <dc:title>Diapositiva 1</dc:title>
</cp:coreProperties>
</file>